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9"/>
  </p:notes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7" r:id="rId12"/>
    <p:sldId id="268" r:id="rId13"/>
    <p:sldId id="269" r:id="rId14"/>
    <p:sldId id="266" r:id="rId15"/>
    <p:sldId id="263" r:id="rId16"/>
    <p:sldId id="264" r:id="rId17"/>
    <p:sldId id="265" r:id="rId18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iego Galvan" initials="DG" lastIdx="7" clrIdx="0">
    <p:extLst>
      <p:ext uri="{19B8F6BF-5375-455C-9EA6-DF929625EA0E}">
        <p15:presenceInfo xmlns:p15="http://schemas.microsoft.com/office/powerpoint/2012/main" userId="8e3d7d9497d49fad" providerId="Windows Live"/>
      </p:ext>
    </p:extLst>
  </p:cmAuthor>
  <p:cmAuthor id="2" name="Microsoft Office User" initials="MOU" lastIdx="3" clrIdx="1">
    <p:extLst>
      <p:ext uri="{19B8F6BF-5375-455C-9EA6-DF929625EA0E}">
        <p15:presenceInfo xmlns:p15="http://schemas.microsoft.com/office/powerpoint/2012/main" userId="Microsoft Office Us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050" autoAdjust="0"/>
    <p:restoredTop sz="91897" autoAdjust="0"/>
  </p:normalViewPr>
  <p:slideViewPr>
    <p:cSldViewPr snapToGrid="0">
      <p:cViewPr varScale="1">
        <p:scale>
          <a:sx n="63" d="100"/>
          <a:sy n="63" d="100"/>
        </p:scale>
        <p:origin x="114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3" Type="http://schemas.openxmlformats.org/officeDocument/2006/relationships/customXml" Target="../customXml/item3.xml"/><Relationship Id="rId21" Type="http://schemas.openxmlformats.org/officeDocument/2006/relationships/presProps" Target="presProp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commentAuthors" Target="commentAuthor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tableStyles" Target="tableStyles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theme" Target="theme/theme1.xml"/><Relationship Id="rId10" Type="http://schemas.openxmlformats.org/officeDocument/2006/relationships/slide" Target="slides/slide6.xml"/><Relationship Id="rId19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82A9B8-621F-5F42-A15D-9C2066190375}" type="datetimeFigureOut">
              <a:rPr lang="pt-BR" smtClean="0"/>
              <a:t>30/10/2021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F633E2-4A2A-B34F-A038-6EDCA9ADE2BC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858021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F633E2-4A2A-B34F-A038-6EDCA9ADE2BC}" type="slidenum">
              <a:rPr lang="pt-BR" smtClean="0"/>
              <a:t>5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499855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6BDFF-60B2-4616-80F3-A30FD8659017}" type="datetimeFigureOut">
              <a:rPr lang="pt-BR" smtClean="0"/>
              <a:t>30/10/202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07D8-8D6F-4418-89B6-C68F110842FD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330052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6BDFF-60B2-4616-80F3-A30FD8659017}" type="datetimeFigureOut">
              <a:rPr lang="pt-BR" smtClean="0"/>
              <a:t>30/10/202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07D8-8D6F-4418-89B6-C68F110842FD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9492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6BDFF-60B2-4616-80F3-A30FD8659017}" type="datetimeFigureOut">
              <a:rPr lang="pt-BR" smtClean="0"/>
              <a:t>30/10/202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07D8-8D6F-4418-89B6-C68F110842FD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18782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6BDFF-60B2-4616-80F3-A30FD8659017}" type="datetimeFigureOut">
              <a:rPr lang="pt-BR" smtClean="0"/>
              <a:t>30/10/202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07D8-8D6F-4418-89B6-C68F110842FD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77952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6BDFF-60B2-4616-80F3-A30FD8659017}" type="datetimeFigureOut">
              <a:rPr lang="pt-BR" smtClean="0"/>
              <a:t>30/10/202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07D8-8D6F-4418-89B6-C68F110842FD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77845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6BDFF-60B2-4616-80F3-A30FD8659017}" type="datetimeFigureOut">
              <a:rPr lang="pt-BR" smtClean="0"/>
              <a:t>30/10/2021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07D8-8D6F-4418-89B6-C68F110842FD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12202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6BDFF-60B2-4616-80F3-A30FD8659017}" type="datetimeFigureOut">
              <a:rPr lang="pt-BR" smtClean="0"/>
              <a:t>30/10/2021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07D8-8D6F-4418-89B6-C68F110842FD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65992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6BDFF-60B2-4616-80F3-A30FD8659017}" type="datetimeFigureOut">
              <a:rPr lang="pt-BR" smtClean="0"/>
              <a:t>30/10/2021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07D8-8D6F-4418-89B6-C68F110842FD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39224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6BDFF-60B2-4616-80F3-A30FD8659017}" type="datetimeFigureOut">
              <a:rPr lang="pt-BR" smtClean="0"/>
              <a:t>30/10/2021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07D8-8D6F-4418-89B6-C68F110842FD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4245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6BDFF-60B2-4616-80F3-A30FD8659017}" type="datetimeFigureOut">
              <a:rPr lang="pt-BR" smtClean="0"/>
              <a:t>30/10/2021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07D8-8D6F-4418-89B6-C68F110842FD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015904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6BDFF-60B2-4616-80F3-A30FD8659017}" type="datetimeFigureOut">
              <a:rPr lang="pt-BR" smtClean="0"/>
              <a:t>30/10/2021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07D8-8D6F-4418-89B6-C68F110842FD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83929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F6BDFF-60B2-4616-80F3-A30FD8659017}" type="datetimeFigureOut">
              <a:rPr lang="pt-BR" smtClean="0"/>
              <a:t>30/10/202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6307D8-8D6F-4418-89B6-C68F110842FD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18407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/>
          <p:cNvSpPr txBox="1"/>
          <p:nvPr/>
        </p:nvSpPr>
        <p:spPr>
          <a:xfrm>
            <a:off x="5110386" y="581114"/>
            <a:ext cx="21674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/>
              <a:t>Supplementary </a:t>
            </a:r>
            <a:r>
              <a:rPr lang="pt-BR" b="1"/>
              <a:t>file 3</a:t>
            </a:r>
            <a:endParaRPr lang="pt-BR" dirty="0"/>
          </a:p>
        </p:txBody>
      </p:sp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892174" y="5921235"/>
            <a:ext cx="9969789" cy="48756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A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Hierarchical clustering dendrogram and heat map for 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essential oil compounds (EOC) and reference drugs (bold) against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in protease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with values referring to Docking Score (DS).</a:t>
            </a:r>
            <a:endParaRPr lang="pt-B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B497C94-FE7B-4C34-842A-38E5B20B496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925600" y="-1159015"/>
            <a:ext cx="4215379" cy="96573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498617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892175" y="5921235"/>
            <a:ext cx="10516560" cy="48756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7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ierarchical clustering dendrogram and heat map for 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C and reference drugs (bold) against </a:t>
            </a:r>
            <a:r>
              <a:rPr lang="it-IT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licase Polyprotein 1a (RP1a) 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referring to BE.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pt-B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5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19" t="14660" r="16273" b="25696"/>
          <a:stretch/>
        </p:blipFill>
        <p:spPr bwMode="auto">
          <a:xfrm>
            <a:off x="3551274" y="2094127"/>
            <a:ext cx="4938868" cy="291380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361218853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892175" y="5921235"/>
            <a:ext cx="10516560" cy="28027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8: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ierarchical clustering dendrogram and heat map for 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C against </a:t>
            </a:r>
            <a:r>
              <a:rPr lang="it-IT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tepsin B </a:t>
            </a:r>
            <a:r>
              <a:rPr lang="it-IT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it-IT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catepsin L </a:t>
            </a:r>
            <a:r>
              <a:rPr lang="it-IT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it-IT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referring to BE.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pt-B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8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494" b="21651"/>
          <a:stretch/>
        </p:blipFill>
        <p:spPr bwMode="auto">
          <a:xfrm>
            <a:off x="1495277" y="2187430"/>
            <a:ext cx="4625975" cy="249682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8" name="Picture 9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77" t="13648" r="977" b="19879"/>
          <a:stretch/>
        </p:blipFill>
        <p:spPr bwMode="auto">
          <a:xfrm>
            <a:off x="6747938" y="2365230"/>
            <a:ext cx="4512310" cy="231902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0" name="CaixaDeTexto 9"/>
          <p:cNvSpPr txBox="1"/>
          <p:nvPr/>
        </p:nvSpPr>
        <p:spPr>
          <a:xfrm>
            <a:off x="1143899" y="361507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1" name="CaixaDeTexto 10"/>
          <p:cNvSpPr txBox="1"/>
          <p:nvPr/>
        </p:nvSpPr>
        <p:spPr>
          <a:xfrm>
            <a:off x="6472630" y="361507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00964519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892175" y="5921235"/>
            <a:ext cx="10516560" cy="28027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9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ierarchical clustering dendrogram and heat map for 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C against 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NA-dependent RNA polymerase with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referring to DS.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pt-B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0" name="Picture 12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652"/>
          <a:stretch/>
        </p:blipFill>
        <p:spPr bwMode="auto">
          <a:xfrm rot="5400000">
            <a:off x="4524364" y="-199392"/>
            <a:ext cx="3339497" cy="773438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403884946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892175" y="5921235"/>
            <a:ext cx="10516560" cy="28027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0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ierarchical clustering dendrogram and heat map for 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C against </a:t>
            </a:r>
            <a:r>
              <a:rPr lang="it-IT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doribonuclease (EndoU) with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referring to DS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pt-B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10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35" t="997" r="776" b="9036"/>
          <a:stretch/>
        </p:blipFill>
        <p:spPr bwMode="auto">
          <a:xfrm rot="5400000">
            <a:off x="4946535" y="-1253659"/>
            <a:ext cx="3887716" cy="903668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317699625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892175" y="5921235"/>
            <a:ext cx="10516560" cy="28027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1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ierarchical clustering dendrogram and heat map for 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C against </a:t>
            </a:r>
            <a:r>
              <a:rPr lang="it-IT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P ribose phosphatase 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referring to DS.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pt-B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11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51" t="663" r="1960" b="9262"/>
          <a:stretch/>
        </p:blipFill>
        <p:spPr bwMode="auto">
          <a:xfrm rot="5400000">
            <a:off x="4674568" y="-306349"/>
            <a:ext cx="3509549" cy="813974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7648856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892174" y="5921235"/>
            <a:ext cx="10260735" cy="48756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B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Hierarchical clustering dendrogram and heat map for 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C and reference drugs (bold) against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in protease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with values referring to Binding Energy (BE).</a:t>
            </a:r>
            <a:endParaRPr lang="pt-B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F3AD452-A95A-478D-A08E-88582374BF9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4460457" y="-1531014"/>
            <a:ext cx="3852984" cy="101138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84116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892175" y="5921235"/>
            <a:ext cx="10516560" cy="48756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A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Hierarchical clustering dendrogram and heat map for 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C and reference drugs (bold) against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ike protein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with values referring to BE. a: receptor binding domain; b: Spike protein; c: Spike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ctodomai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d: Spike glycoprotein. </a:t>
            </a:r>
          </a:p>
        </p:txBody>
      </p:sp>
      <p:pic>
        <p:nvPicPr>
          <p:cNvPr id="5" name="Picture 17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28" t="9214" b="9975"/>
          <a:stretch/>
        </p:blipFill>
        <p:spPr bwMode="auto">
          <a:xfrm rot="5400000">
            <a:off x="4293412" y="-1353076"/>
            <a:ext cx="4109049" cy="9527371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16636855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1238538" y="6039770"/>
            <a:ext cx="10516560" cy="48756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B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Hierarchical clustering dendrogram and heat map for 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C and reference drugs (bold) against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ike protein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with values referring to DS. a: receptor binding domain; b: Spike protein; c: Spike ectodomain; d: Spike glycoprotein.   </a:t>
            </a:r>
          </a:p>
        </p:txBody>
      </p:sp>
      <p:pic>
        <p:nvPicPr>
          <p:cNvPr id="7" name="Picture 18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55" t="9422" r="2944" b="10893"/>
          <a:stretch/>
        </p:blipFill>
        <p:spPr bwMode="auto">
          <a:xfrm rot="5400000">
            <a:off x="4149316" y="-988884"/>
            <a:ext cx="4027180" cy="902971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5257205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892175" y="5921235"/>
            <a:ext cx="10516560" cy="477888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A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Hierarchical clustering dendrogram and heat map for 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C against 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giotensin converting enzyme 2 (ACE2) with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referring to BE. a: ACE2; b: Spike ACE2.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pt-B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4924529-829F-4D52-B0F6-205F3CB9E06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733910" y="-1201153"/>
            <a:ext cx="3576835" cy="92603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56861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892175" y="5921235"/>
            <a:ext cx="10516560" cy="48756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B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Hierarchical clustering dendrogram and heat map for 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C and reference drugs (bold) against 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giotensin converting enzyme 2 (ACE2) with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referring to DS.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pt-B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16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19" t="12889" r="9850" b="18864"/>
          <a:stretch/>
        </p:blipFill>
        <p:spPr bwMode="auto">
          <a:xfrm>
            <a:off x="3902148" y="2112689"/>
            <a:ext cx="4566987" cy="286334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45493110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837720" y="5907554"/>
            <a:ext cx="10516560" cy="48756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: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ierarchical clustering dendrogram and heat map for 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C and reference drugs (bold) against ACE2-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lang="it-IT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 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lex with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referring to DS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BE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.</a:t>
            </a:r>
            <a:r>
              <a:rPr lang="it-IT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pt-BR" sz="11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13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59" t="23252" r="8491" b="27460"/>
          <a:stretch/>
        </p:blipFill>
        <p:spPr bwMode="auto">
          <a:xfrm>
            <a:off x="6638290" y="2828290"/>
            <a:ext cx="3359150" cy="155575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8" name="Picture 14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4560" y="2255520"/>
            <a:ext cx="3281680" cy="2346960"/>
          </a:xfrm>
          <a:prstGeom prst="rect">
            <a:avLst/>
          </a:prstGeom>
        </p:spPr>
      </p:pic>
      <p:sp>
        <p:nvSpPr>
          <p:cNvPr id="2" name="CaixaDeTexto 1"/>
          <p:cNvSpPr txBox="1"/>
          <p:nvPr/>
        </p:nvSpPr>
        <p:spPr>
          <a:xfrm>
            <a:off x="1469745" y="333862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CaixaDeTexto 8"/>
          <p:cNvSpPr txBox="1"/>
          <p:nvPr/>
        </p:nvSpPr>
        <p:spPr>
          <a:xfrm>
            <a:off x="6286912" y="334253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0641334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892175" y="5921235"/>
            <a:ext cx="10516560" cy="48756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5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ierarchical clustering dendrogram and heat map for 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C and reference drugs (bold) against </a:t>
            </a:r>
            <a:r>
              <a:rPr lang="it-IT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nsmembrane Serine Protease 2 (TMPRSS2) 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referring to BE.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pt-B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9" name="Picture 7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186" b="25440"/>
          <a:stretch/>
        </p:blipFill>
        <p:spPr bwMode="auto">
          <a:xfrm>
            <a:off x="3402420" y="1976226"/>
            <a:ext cx="5355368" cy="290411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00878438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892175" y="5921235"/>
            <a:ext cx="10516560" cy="48756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6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ierarchical clustering dendrogram and heat map for 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C and reference drugs (bold) against </a:t>
            </a:r>
            <a:r>
              <a:rPr lang="it-IT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nstructured Protein 9 RNA binding protein 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referring to BE.</a:t>
            </a:r>
            <a:r>
              <a:rPr lang="it-IT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pt-B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6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78" t="18197" r="14894" b="26955"/>
          <a:stretch/>
        </p:blipFill>
        <p:spPr bwMode="auto">
          <a:xfrm>
            <a:off x="3434316" y="2012419"/>
            <a:ext cx="5349447" cy="286792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6589334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16CCE96A69A814589FBA344B31FF71E" ma:contentTypeVersion="9" ma:contentTypeDescription="Create a new document." ma:contentTypeScope="" ma:versionID="24188a3e5eafe683902a1a2e93a682a3">
  <xsd:schema xmlns:xsd="http://www.w3.org/2001/XMLSchema" xmlns:xs="http://www.w3.org/2001/XMLSchema" xmlns:p="http://schemas.microsoft.com/office/2006/metadata/properties" xmlns:ns3="d5d0204b-3f24-44e0-92ab-f9338ef4ea96" targetNamespace="http://schemas.microsoft.com/office/2006/metadata/properties" ma:root="true" ma:fieldsID="b743cc28f627fd89260e637c2c94fbd6" ns3:_="">
    <xsd:import namespace="d5d0204b-3f24-44e0-92ab-f9338ef4ea96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5d0204b-3f24-44e0-92ab-f9338ef4ea9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6394C751-8E8B-43B2-9A54-278DE0028B6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5d0204b-3f24-44e0-92ab-f9338ef4ea9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7AAFDC52-90D4-4D91-B7C3-475AF6D89E50}">
  <ds:schemaRefs>
    <ds:schemaRef ds:uri="http://purl.org/dc/elements/1.1/"/>
    <ds:schemaRef ds:uri="http://schemas.microsoft.com/office/infopath/2007/PartnerControls"/>
    <ds:schemaRef ds:uri="http://purl.org/dc/dcmitype/"/>
    <ds:schemaRef ds:uri="http://schemas.openxmlformats.org/package/2006/metadata/core-properties"/>
    <ds:schemaRef ds:uri="http://www.w3.org/XML/1998/namespace"/>
    <ds:schemaRef ds:uri="http://schemas.microsoft.com/office/2006/metadata/properties"/>
    <ds:schemaRef ds:uri="d5d0204b-3f24-44e0-92ab-f9338ef4ea96"/>
    <ds:schemaRef ds:uri="http://schemas.microsoft.com/office/2006/documentManagement/types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1804F7C3-497D-4A44-A02A-7029A44C289F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45</TotalTime>
  <Words>474</Words>
  <Application>Microsoft Office PowerPoint</Application>
  <PresentationFormat>Widescreen</PresentationFormat>
  <Paragraphs>20</Paragraphs>
  <Slides>1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Light</vt:lpstr>
      <vt:lpstr>Times New Roman</vt:lpstr>
      <vt:lpstr>Tema do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Luiz Torres</dc:creator>
  <cp:lastModifiedBy>Luiz Torres</cp:lastModifiedBy>
  <cp:revision>30</cp:revision>
  <dcterms:created xsi:type="dcterms:W3CDTF">2021-07-16T14:43:42Z</dcterms:created>
  <dcterms:modified xsi:type="dcterms:W3CDTF">2021-10-30T17:59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16CCE96A69A814589FBA344B31FF71E</vt:lpwstr>
  </property>
</Properties>
</file>